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73" r:id="rId2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68" userDrawn="1">
          <p15:clr>
            <a:srgbClr val="A4A3A4"/>
          </p15:clr>
        </p15:guide>
        <p15:guide id="2" pos="238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476" autoAdjust="0"/>
    <p:restoredTop sz="92986" autoAdjust="0"/>
  </p:normalViewPr>
  <p:slideViewPr>
    <p:cSldViewPr snapToGrid="0" snapToObjects="1">
      <p:cViewPr varScale="1">
        <p:scale>
          <a:sx n="59" d="100"/>
          <a:sy n="59" d="100"/>
        </p:scale>
        <p:origin x="2892" y="72"/>
      </p:cViewPr>
      <p:guideLst>
        <p:guide orient="horz" pos="3368"/>
        <p:guide pos="2381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2263235-826B-4DBE-BF6E-0C185A76ABA3}" type="datetimeFigureOut">
              <a:rPr lang="zh-CN" altLang="en-US" smtClean="0"/>
              <a:pPr/>
              <a:t>2018/8/2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150AFE5-DE01-4638-B01A-C45FD2F995A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84380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1pPr>
    <a:lvl2pPr marL="521437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2pPr>
    <a:lvl3pPr marL="1042873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3pPr>
    <a:lvl4pPr marL="1564310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4pPr>
    <a:lvl5pPr marL="2085746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5pPr>
    <a:lvl6pPr marL="2607183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6pPr>
    <a:lvl7pPr marL="3128620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7pPr>
    <a:lvl8pPr marL="3650056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8pPr>
    <a:lvl9pPr marL="4171493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30517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61377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85694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47267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50588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03844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4484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68195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74091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07847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70857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90948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42402" y="363852"/>
            <a:ext cx="683200" cy="29591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323" b="1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Fig. </a:t>
            </a:r>
            <a:r>
              <a:rPr lang="en-US" altLang="zh-CN" sz="1323" b="1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S4</a:t>
            </a:r>
            <a:endParaRPr lang="en-US" altLang="zh-CN" sz="1323" b="1" dirty="0">
              <a:latin typeface="Times New Roman" panose="02020603050405020304" pitchFamily="18" charset="0"/>
              <a:ea typeface="Arial" charset="0"/>
              <a:cs typeface="Times New Roman" panose="02020603050405020304" pitchFamily="18" charset="0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804" t="4902" r="20392" b="6471"/>
          <a:stretch/>
        </p:blipFill>
        <p:spPr>
          <a:xfrm>
            <a:off x="2742118" y="1520433"/>
            <a:ext cx="3220111" cy="4297705"/>
          </a:xfrm>
          <a:prstGeom prst="rect">
            <a:avLst/>
          </a:prstGeom>
        </p:spPr>
      </p:pic>
      <p:sp>
        <p:nvSpPr>
          <p:cNvPr id="6" name="文本框 48"/>
          <p:cNvSpPr txBox="1"/>
          <p:nvPr/>
        </p:nvSpPr>
        <p:spPr>
          <a:xfrm>
            <a:off x="3633510" y="5886277"/>
            <a:ext cx="1252566" cy="295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32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log10(</a:t>
            </a:r>
            <a:r>
              <a:rPr lang="en-US" altLang="zh-CN" sz="1323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value</a:t>
            </a:r>
            <a:r>
              <a:rPr lang="en-US" altLang="zh-CN" sz="132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zh-CN" altLang="en-US" sz="1323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48"/>
          <p:cNvSpPr txBox="1"/>
          <p:nvPr/>
        </p:nvSpPr>
        <p:spPr>
          <a:xfrm>
            <a:off x="3063357" y="1281511"/>
            <a:ext cx="2648440" cy="295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32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most enriched GO terms</a:t>
            </a:r>
            <a:endParaRPr lang="zh-CN" altLang="en-US" sz="1323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2801108" y="5709822"/>
            <a:ext cx="41420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0 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26"/>
          <p:cNvSpPr txBox="1"/>
          <p:nvPr/>
        </p:nvSpPr>
        <p:spPr>
          <a:xfrm>
            <a:off x="3342934" y="5701495"/>
            <a:ext cx="300941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26"/>
          <p:cNvSpPr txBox="1"/>
          <p:nvPr/>
        </p:nvSpPr>
        <p:spPr>
          <a:xfrm>
            <a:off x="3870751" y="5712944"/>
            <a:ext cx="29237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26"/>
          <p:cNvSpPr txBox="1"/>
          <p:nvPr/>
        </p:nvSpPr>
        <p:spPr>
          <a:xfrm>
            <a:off x="4412684" y="5709822"/>
            <a:ext cx="41998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26"/>
          <p:cNvSpPr txBox="1"/>
          <p:nvPr/>
        </p:nvSpPr>
        <p:spPr>
          <a:xfrm>
            <a:off x="4936221" y="5701495"/>
            <a:ext cx="242018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5865396" y="3336576"/>
            <a:ext cx="2284845" cy="295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23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ological process</a:t>
            </a:r>
            <a:endParaRPr lang="zh-CN" altLang="en-US" sz="132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5850555" y="3526306"/>
            <a:ext cx="2284845" cy="295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23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ular component</a:t>
            </a:r>
            <a:endParaRPr lang="zh-CN" altLang="en-US" sz="132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48"/>
          <p:cNvSpPr txBox="1"/>
          <p:nvPr/>
        </p:nvSpPr>
        <p:spPr>
          <a:xfrm>
            <a:off x="5865379" y="3708337"/>
            <a:ext cx="2284845" cy="295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323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lecular function</a:t>
            </a:r>
            <a:endParaRPr lang="zh-CN" altLang="en-US" sz="132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1212739" y="1546765"/>
            <a:ext cx="165550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quence-specific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DNA binding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196846" y="1755022"/>
            <a:ext cx="284842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quence-specific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DNA binding transcription factor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…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1226261" y="1963878"/>
            <a:ext cx="165550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stidine kinase binding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1559214" y="2161962"/>
            <a:ext cx="165550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bonuclease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III activity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827780" y="2364636"/>
            <a:ext cx="2040463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stidine </a:t>
            </a:r>
            <a:r>
              <a:rPr lang="en-US" altLang="zh-CN" sz="88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osphotransfer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 kinase activity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995176" y="2985340"/>
            <a:ext cx="2040463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steine-type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dopeptidase activity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1811515" y="2576350"/>
            <a:ext cx="107848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oxidase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vity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1994971" y="2774586"/>
            <a:ext cx="858108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itin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nding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1848011" y="3192501"/>
            <a:ext cx="113161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al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ion binding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1865194" y="3404428"/>
            <a:ext cx="113161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itinase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vity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1399778" y="3622310"/>
            <a:ext cx="1516600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ponse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</a:t>
            </a:r>
            <a:r>
              <a:rPr lang="en-US" altLang="zh-CN" sz="88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rassinosteroid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1140302" y="3818735"/>
            <a:ext cx="177985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gulation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protein localization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674753" y="4035977"/>
            <a:ext cx="222207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gulation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transcription, DNA-</a:t>
            </a:r>
            <a:r>
              <a:rPr lang="en-US" altLang="zh-CN" sz="88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mplated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1574646" y="4232742"/>
            <a:ext cx="141916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pid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abolic proces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2045055" y="4433529"/>
            <a:ext cx="826518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ototropism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1576732" y="5277997"/>
            <a:ext cx="135001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itin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tabolic proces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749458" y="4640885"/>
            <a:ext cx="2211786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ll macromolecule catabolic proces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1429156" y="4850715"/>
            <a:ext cx="1632913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ponse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biotic stimulu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882019" y="5055319"/>
            <a:ext cx="2007978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RNA phosphodiester bond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hydrolysis…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1764330" y="5480824"/>
            <a:ext cx="113249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tracellular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gion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5162860" y="1564614"/>
            <a:ext cx="346918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>
            <a:off x="5160383" y="1754843"/>
            <a:ext cx="346918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16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3800882" y="1968947"/>
            <a:ext cx="26216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3745899" y="2179129"/>
            <a:ext cx="26216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3518023" y="2389251"/>
            <a:ext cx="26216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3515548" y="2594303"/>
            <a:ext cx="26216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3471269" y="2794730"/>
            <a:ext cx="26216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3468786" y="3007195"/>
            <a:ext cx="26216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/>
          <p:cNvSpPr txBox="1"/>
          <p:nvPr/>
        </p:nvSpPr>
        <p:spPr>
          <a:xfrm>
            <a:off x="3431876" y="3215196"/>
            <a:ext cx="33420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3409613" y="3409491"/>
            <a:ext cx="26216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文本框 45"/>
          <p:cNvSpPr txBox="1"/>
          <p:nvPr/>
        </p:nvSpPr>
        <p:spPr>
          <a:xfrm>
            <a:off x="4527257" y="3632346"/>
            <a:ext cx="26216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文本框 46"/>
          <p:cNvSpPr txBox="1"/>
          <p:nvPr/>
        </p:nvSpPr>
        <p:spPr>
          <a:xfrm>
            <a:off x="4461660" y="3840596"/>
            <a:ext cx="26216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/>
          <p:cNvSpPr txBox="1"/>
          <p:nvPr/>
        </p:nvSpPr>
        <p:spPr>
          <a:xfrm>
            <a:off x="3616253" y="4043899"/>
            <a:ext cx="334539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48"/>
          <p:cNvSpPr txBox="1"/>
          <p:nvPr/>
        </p:nvSpPr>
        <p:spPr>
          <a:xfrm>
            <a:off x="3659851" y="4253285"/>
            <a:ext cx="26216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/>
          <p:cNvSpPr txBox="1"/>
          <p:nvPr/>
        </p:nvSpPr>
        <p:spPr>
          <a:xfrm>
            <a:off x="3659849" y="4447993"/>
            <a:ext cx="26216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/>
          <p:cNvSpPr txBox="1"/>
          <p:nvPr/>
        </p:nvSpPr>
        <p:spPr>
          <a:xfrm>
            <a:off x="3346154" y="4658765"/>
            <a:ext cx="26216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文本框 51"/>
          <p:cNvSpPr txBox="1"/>
          <p:nvPr/>
        </p:nvSpPr>
        <p:spPr>
          <a:xfrm>
            <a:off x="3339262" y="4873464"/>
            <a:ext cx="26216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/>
          <p:cNvSpPr txBox="1"/>
          <p:nvPr/>
        </p:nvSpPr>
        <p:spPr>
          <a:xfrm>
            <a:off x="3336855" y="5070143"/>
            <a:ext cx="26216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文本框 53"/>
          <p:cNvSpPr txBox="1"/>
          <p:nvPr/>
        </p:nvSpPr>
        <p:spPr>
          <a:xfrm>
            <a:off x="3306936" y="5286369"/>
            <a:ext cx="26216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文本框 54"/>
          <p:cNvSpPr txBox="1"/>
          <p:nvPr/>
        </p:nvSpPr>
        <p:spPr>
          <a:xfrm>
            <a:off x="3348925" y="5484009"/>
            <a:ext cx="26216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48284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63</TotalTime>
  <Words>109</Words>
  <Application>Microsoft Office PowerPoint</Application>
  <PresentationFormat>自定义</PresentationFormat>
  <Paragraphs>5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等线</vt:lpstr>
      <vt:lpstr>等线 Light</vt:lpstr>
      <vt:lpstr>Arial</vt:lpstr>
      <vt:lpstr>Calibri</vt:lpstr>
      <vt:lpstr>Calibri Light</vt:lpstr>
      <vt:lpstr>Times New Roman</vt:lpstr>
      <vt:lpstr>Office Theme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yzyangyan</cp:lastModifiedBy>
  <cp:revision>159</cp:revision>
  <dcterms:created xsi:type="dcterms:W3CDTF">2017-02-03T22:12:08Z</dcterms:created>
  <dcterms:modified xsi:type="dcterms:W3CDTF">2018-08-23T04:40:34Z</dcterms:modified>
</cp:coreProperties>
</file>